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9"/>
    <p:restoredTop sz="94721"/>
  </p:normalViewPr>
  <p:slideViewPr>
    <p:cSldViewPr snapToGrid="0" snapToObjects="1">
      <p:cViewPr>
        <p:scale>
          <a:sx n="93" d="100"/>
          <a:sy n="93" d="100"/>
        </p:scale>
        <p:origin x="-168" y="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verage_Plot!$H$17</c:f>
              <c:strCache>
                <c:ptCount val="1"/>
                <c:pt idx="0">
                  <c:v>24 Hours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Plot!$I$6:$I$13</c:f>
                <c:numCache>
                  <c:formatCode>General</c:formatCode>
                  <c:ptCount val="8"/>
                  <c:pt idx="0">
                    <c:v>1.445024913280043</c:v>
                  </c:pt>
                  <c:pt idx="1">
                    <c:v>0.77047611542762595</c:v>
                  </c:pt>
                  <c:pt idx="2">
                    <c:v>1.086290169951535</c:v>
                  </c:pt>
                  <c:pt idx="3">
                    <c:v>0.38074021472798403</c:v>
                  </c:pt>
                  <c:pt idx="4">
                    <c:v>1.1131086100546419</c:v>
                  </c:pt>
                  <c:pt idx="5">
                    <c:v>1.0346803585863831</c:v>
                  </c:pt>
                  <c:pt idx="6">
                    <c:v>1.059033888871256</c:v>
                  </c:pt>
                  <c:pt idx="7">
                    <c:v>1.4882259013111321</c:v>
                  </c:pt>
                </c:numCache>
              </c:numRef>
            </c:plus>
            <c:minus>
              <c:numRef>
                <c:f>Average_Plot!$I$6:$I$13</c:f>
                <c:numCache>
                  <c:formatCode>General</c:formatCode>
                  <c:ptCount val="8"/>
                  <c:pt idx="0">
                    <c:v>1.445024913280043</c:v>
                  </c:pt>
                  <c:pt idx="1">
                    <c:v>0.77047611542762595</c:v>
                  </c:pt>
                  <c:pt idx="2">
                    <c:v>1.086290169951535</c:v>
                  </c:pt>
                  <c:pt idx="3">
                    <c:v>0.38074021472798403</c:v>
                  </c:pt>
                  <c:pt idx="4">
                    <c:v>1.1131086100546419</c:v>
                  </c:pt>
                  <c:pt idx="5">
                    <c:v>1.0346803585863831</c:v>
                  </c:pt>
                  <c:pt idx="6">
                    <c:v>1.059033888871256</c:v>
                  </c:pt>
                  <c:pt idx="7">
                    <c:v>1.48822590131113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Plot!$G$18:$G$25</c:f>
              <c:strCache>
                <c:ptCount val="8"/>
                <c:pt idx="0">
                  <c:v>M1_5</c:v>
                </c:pt>
                <c:pt idx="1">
                  <c:v>M2_5</c:v>
                </c:pt>
                <c:pt idx="2">
                  <c:v>M5_5</c:v>
                </c:pt>
                <c:pt idx="3">
                  <c:v>M6_5</c:v>
                </c:pt>
                <c:pt idx="4">
                  <c:v>M7_5</c:v>
                </c:pt>
                <c:pt idx="5">
                  <c:v>M8_5</c:v>
                </c:pt>
                <c:pt idx="6">
                  <c:v>M9_5</c:v>
                </c:pt>
                <c:pt idx="7">
                  <c:v>Parent diploid</c:v>
                </c:pt>
              </c:strCache>
            </c:strRef>
          </c:cat>
          <c:val>
            <c:numRef>
              <c:f>Average_Plot!$H$18:$H$25</c:f>
              <c:numCache>
                <c:formatCode>0.00</c:formatCode>
                <c:ptCount val="8"/>
                <c:pt idx="0">
                  <c:v>60.548999999999999</c:v>
                </c:pt>
                <c:pt idx="1">
                  <c:v>66.575333333333333</c:v>
                </c:pt>
                <c:pt idx="2">
                  <c:v>28.114999999999998</c:v>
                </c:pt>
                <c:pt idx="3">
                  <c:v>35.373666666666658</c:v>
                </c:pt>
                <c:pt idx="4">
                  <c:v>47.184666666666658</c:v>
                </c:pt>
                <c:pt idx="5">
                  <c:v>52.53233333333332</c:v>
                </c:pt>
                <c:pt idx="6">
                  <c:v>27.198333333333331</c:v>
                </c:pt>
                <c:pt idx="7">
                  <c:v>48.646000000000001</c:v>
                </c:pt>
              </c:numCache>
            </c:numRef>
          </c:val>
        </c:ser>
        <c:ser>
          <c:idx val="1"/>
          <c:order val="1"/>
          <c:tx>
            <c:strRef>
              <c:f>Average_Plot!$I$17</c:f>
              <c:strCache>
                <c:ptCount val="1"/>
                <c:pt idx="0">
                  <c:v> 48 Hour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Plot!$N$6:$N$13</c:f>
                <c:numCache>
                  <c:formatCode>General</c:formatCode>
                  <c:ptCount val="8"/>
                  <c:pt idx="0">
                    <c:v>1.925433486545592</c:v>
                  </c:pt>
                  <c:pt idx="1">
                    <c:v>1.740163434214665</c:v>
                  </c:pt>
                  <c:pt idx="2">
                    <c:v>1.737911613914177</c:v>
                  </c:pt>
                  <c:pt idx="3">
                    <c:v>0.75187772351035198</c:v>
                  </c:pt>
                  <c:pt idx="4">
                    <c:v>0.71234947727767595</c:v>
                  </c:pt>
                  <c:pt idx="5">
                    <c:v>0.80372818788443601</c:v>
                  </c:pt>
                  <c:pt idx="6">
                    <c:v>1.881829517606028</c:v>
                  </c:pt>
                  <c:pt idx="7">
                    <c:v>2.6388352438991811</c:v>
                  </c:pt>
                </c:numCache>
              </c:numRef>
            </c:plus>
            <c:minus>
              <c:numRef>
                <c:f>Average_Plot!$N$6:$N$13</c:f>
                <c:numCache>
                  <c:formatCode>General</c:formatCode>
                  <c:ptCount val="8"/>
                  <c:pt idx="0">
                    <c:v>1.925433486545592</c:v>
                  </c:pt>
                  <c:pt idx="1">
                    <c:v>1.740163434214665</c:v>
                  </c:pt>
                  <c:pt idx="2">
                    <c:v>1.737911613914177</c:v>
                  </c:pt>
                  <c:pt idx="3">
                    <c:v>0.75187772351035198</c:v>
                  </c:pt>
                  <c:pt idx="4">
                    <c:v>0.71234947727767595</c:v>
                  </c:pt>
                  <c:pt idx="5">
                    <c:v>0.80372818788443601</c:v>
                  </c:pt>
                  <c:pt idx="6">
                    <c:v>1.881829517606028</c:v>
                  </c:pt>
                  <c:pt idx="7">
                    <c:v>2.63883524389918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Plot!$G$18:$G$25</c:f>
              <c:strCache>
                <c:ptCount val="8"/>
                <c:pt idx="0">
                  <c:v>M1_5</c:v>
                </c:pt>
                <c:pt idx="1">
                  <c:v>M2_5</c:v>
                </c:pt>
                <c:pt idx="2">
                  <c:v>M5_5</c:v>
                </c:pt>
                <c:pt idx="3">
                  <c:v>M6_5</c:v>
                </c:pt>
                <c:pt idx="4">
                  <c:v>M7_5</c:v>
                </c:pt>
                <c:pt idx="5">
                  <c:v>M8_5</c:v>
                </c:pt>
                <c:pt idx="6">
                  <c:v>M9_5</c:v>
                </c:pt>
                <c:pt idx="7">
                  <c:v>Parent diploid</c:v>
                </c:pt>
              </c:strCache>
            </c:strRef>
          </c:cat>
          <c:val>
            <c:numRef>
              <c:f>Average_Plot!$I$18:$I$25</c:f>
              <c:numCache>
                <c:formatCode>0.00</c:formatCode>
                <c:ptCount val="8"/>
                <c:pt idx="0">
                  <c:v>70.638666666666666</c:v>
                </c:pt>
                <c:pt idx="1">
                  <c:v>77.61733333333332</c:v>
                </c:pt>
                <c:pt idx="2">
                  <c:v>43.050333333333327</c:v>
                </c:pt>
                <c:pt idx="3">
                  <c:v>47.553333333333327</c:v>
                </c:pt>
                <c:pt idx="4">
                  <c:v>56.105333333333327</c:v>
                </c:pt>
                <c:pt idx="5">
                  <c:v>59.682000000000002</c:v>
                </c:pt>
                <c:pt idx="6">
                  <c:v>46.893000000000001</c:v>
                </c:pt>
                <c:pt idx="7">
                  <c:v>56.137333333333338</c:v>
                </c:pt>
              </c:numCache>
            </c:numRef>
          </c:val>
        </c:ser>
        <c:ser>
          <c:idx val="2"/>
          <c:order val="2"/>
          <c:tx>
            <c:strRef>
              <c:f>Average_Plot!$J$17</c:f>
              <c:strCache>
                <c:ptCount val="1"/>
                <c:pt idx="0">
                  <c:v>72 Hour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Plot!$S$6:$S$13</c:f>
                <c:numCache>
                  <c:formatCode>General</c:formatCode>
                  <c:ptCount val="8"/>
                  <c:pt idx="0">
                    <c:v>0.94155267746655902</c:v>
                  </c:pt>
                  <c:pt idx="1">
                    <c:v>0.84562291307125204</c:v>
                  </c:pt>
                  <c:pt idx="2">
                    <c:v>0.718378807532009</c:v>
                  </c:pt>
                  <c:pt idx="3">
                    <c:v>0.67966666666666697</c:v>
                  </c:pt>
                  <c:pt idx="4">
                    <c:v>0.65933434445490302</c:v>
                  </c:pt>
                  <c:pt idx="5">
                    <c:v>1.719224857635298</c:v>
                  </c:pt>
                  <c:pt idx="6">
                    <c:v>1.515955620869041</c:v>
                  </c:pt>
                  <c:pt idx="7">
                    <c:v>2.0710903193996919</c:v>
                  </c:pt>
                </c:numCache>
              </c:numRef>
            </c:plus>
            <c:minus>
              <c:numRef>
                <c:f>Average_Plot!$S$6:$S$13</c:f>
                <c:numCache>
                  <c:formatCode>General</c:formatCode>
                  <c:ptCount val="8"/>
                  <c:pt idx="0">
                    <c:v>0.94155267746655902</c:v>
                  </c:pt>
                  <c:pt idx="1">
                    <c:v>0.84562291307125204</c:v>
                  </c:pt>
                  <c:pt idx="2">
                    <c:v>0.718378807532009</c:v>
                  </c:pt>
                  <c:pt idx="3">
                    <c:v>0.67966666666666697</c:v>
                  </c:pt>
                  <c:pt idx="4">
                    <c:v>0.65933434445490302</c:v>
                  </c:pt>
                  <c:pt idx="5">
                    <c:v>1.719224857635298</c:v>
                  </c:pt>
                  <c:pt idx="6">
                    <c:v>1.515955620869041</c:v>
                  </c:pt>
                  <c:pt idx="7">
                    <c:v>2.07109031939969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Plot!$G$18:$G$25</c:f>
              <c:strCache>
                <c:ptCount val="8"/>
                <c:pt idx="0">
                  <c:v>M1_5</c:v>
                </c:pt>
                <c:pt idx="1">
                  <c:v>M2_5</c:v>
                </c:pt>
                <c:pt idx="2">
                  <c:v>M5_5</c:v>
                </c:pt>
                <c:pt idx="3">
                  <c:v>M6_5</c:v>
                </c:pt>
                <c:pt idx="4">
                  <c:v>M7_5</c:v>
                </c:pt>
                <c:pt idx="5">
                  <c:v>M8_5</c:v>
                </c:pt>
                <c:pt idx="6">
                  <c:v>M9_5</c:v>
                </c:pt>
                <c:pt idx="7">
                  <c:v>Parent diploid</c:v>
                </c:pt>
              </c:strCache>
            </c:strRef>
          </c:cat>
          <c:val>
            <c:numRef>
              <c:f>Average_Plot!$J$18:$J$25</c:f>
              <c:numCache>
                <c:formatCode>0.00</c:formatCode>
                <c:ptCount val="8"/>
                <c:pt idx="0">
                  <c:v>79.411666666666676</c:v>
                </c:pt>
                <c:pt idx="1">
                  <c:v>78.674333333333337</c:v>
                </c:pt>
                <c:pt idx="2">
                  <c:v>47.69766666666667</c:v>
                </c:pt>
                <c:pt idx="3">
                  <c:v>57.856333333333339</c:v>
                </c:pt>
                <c:pt idx="4">
                  <c:v>50.151333333333334</c:v>
                </c:pt>
                <c:pt idx="5">
                  <c:v>62.443666666666672</c:v>
                </c:pt>
                <c:pt idx="6">
                  <c:v>51.17166666666666</c:v>
                </c:pt>
                <c:pt idx="7">
                  <c:v>75.381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7408256"/>
        <c:axId val="157459584"/>
      </c:barChart>
      <c:catAx>
        <c:axId val="1574082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_5 </a:t>
                </a:r>
                <a:r>
                  <a:rPr lang="en-US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ines</a:t>
                </a:r>
              </a:p>
            </c:rich>
          </c:tx>
          <c:layout>
            <c:manualLayout>
              <c:xMode val="edge"/>
              <c:yMode val="edge"/>
              <c:x val="0.50179368437324001"/>
              <c:y val="0.86671987129493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7459584"/>
        <c:crosses val="autoZero"/>
        <c:auto val="1"/>
        <c:lblAlgn val="ctr"/>
        <c:lblOffset val="100"/>
        <c:noMultiLvlLbl val="0"/>
      </c:catAx>
      <c:valAx>
        <c:axId val="157459584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porulation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% (MI+MII)</a:t>
                </a:r>
                <a:endParaRPr lang="en-US" sz="1200" b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5759132791518599E-2"/>
              <c:y val="0.1534950074687700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740825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8711302923232003"/>
          <c:y val="4.0584873030907E-2"/>
          <c:w val="0.27416855809671198"/>
          <c:h val="5.711379410906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807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089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448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843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88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212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991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70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543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774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127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627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6466447"/>
              </p:ext>
            </p:extLst>
          </p:nvPr>
        </p:nvGraphicFramePr>
        <p:xfrm>
          <a:off x="1306490" y="1037410"/>
          <a:ext cx="9097328" cy="4244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288472" y="5738950"/>
            <a:ext cx="1113336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Sporulation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efficiencies of the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_5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lines are variable. The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_5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lines were </a:t>
            </a:r>
            <a:r>
              <a:rPr lang="en-IN" sz="1000" dirty="0" err="1">
                <a:latin typeface="Arial" panose="020B0604020202020204" pitchFamily="34" charset="0"/>
                <a:cs typeface="Arial" panose="020B0604020202020204" pitchFamily="34" charset="0"/>
              </a:rPr>
              <a:t>sporulated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 in liquid media and DAPI stained.  200 cells were counted at each time point and the percentage of dyads, triads and tetrads (MI+MII) plotted.</a:t>
            </a:r>
          </a:p>
        </p:txBody>
      </p:sp>
    </p:spTree>
    <p:extLst>
      <p:ext uri="{BB962C8B-B14F-4D97-AF65-F5344CB8AC3E}">
        <p14:creationId xmlns:p14="http://schemas.microsoft.com/office/powerpoint/2010/main" val="1081725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52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Dutta</dc:creator>
  <cp:lastModifiedBy>IISRTVM</cp:lastModifiedBy>
  <cp:revision>20</cp:revision>
  <dcterms:created xsi:type="dcterms:W3CDTF">2016-09-23T05:19:49Z</dcterms:created>
  <dcterms:modified xsi:type="dcterms:W3CDTF">2017-07-17T12:08:13Z</dcterms:modified>
</cp:coreProperties>
</file>